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6858000" cy="9906000" type="A4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cardo Machado" initials="RM" lastIdx="10" clrIdx="0">
    <p:extLst>
      <p:ext uri="{19B8F6BF-5375-455C-9EA6-DF929625EA0E}">
        <p15:presenceInfo xmlns:p15="http://schemas.microsoft.com/office/powerpoint/2012/main" userId="S-1-5-21-1275210071-1708537768-1343024091-323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47" autoAdjust="0"/>
    <p:restoredTop sz="94660"/>
  </p:normalViewPr>
  <p:slideViewPr>
    <p:cSldViewPr>
      <p:cViewPr varScale="1">
        <p:scale>
          <a:sx n="74" d="100"/>
          <a:sy n="74" d="100"/>
        </p:scale>
        <p:origin x="2772" y="78"/>
      </p:cViewPr>
      <p:guideLst>
        <p:guide orient="horz" pos="3120"/>
        <p:guide pos="2160"/>
      </p:guideLst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56A0A2-FB4C-4DBC-8093-13AB518DD7E7}" type="datetimeFigureOut">
              <a:rPr lang="en-US" smtClean="0"/>
              <a:t>5/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926013"/>
            <a:ext cx="5680075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B1465-33C8-4385-A0BB-9F8DC05EF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3125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2693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7301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24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1279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2542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7245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3128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7011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613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9301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3522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5950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2613" y="477883"/>
            <a:ext cx="5250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igure 1-source data </a:t>
            </a:r>
            <a:r>
              <a:rPr lang="en-US" sz="1200" b="1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3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692696" y="1352600"/>
          <a:ext cx="5184577" cy="2119884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864096"/>
                <a:gridCol w="1700471"/>
                <a:gridCol w="1179850"/>
                <a:gridCol w="1440160"/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mage type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ociated herbivores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removal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tire leaves removed by sharp cuts at the petioles or detachment of entire branches. 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er, rabbits, wood rats and gophers.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area </a:t>
                      </a: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oved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  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m peeling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oval of </a:t>
                      </a: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rk-xylem</a:t>
                      </a:r>
                      <a:r>
                        <a:rPr lang="en-US" sz="10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/or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bium exposed. 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s and wood rats.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m area removed (%)  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chewing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ence of jagged edges and/or holes in the leaves.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rpillars and ants.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area removed (%)  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piercing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ence of characteristic discolored areas on the leaf surface. 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id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ugs and leafhoppers.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area damaged (%)  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612613" y="845474"/>
            <a:ext cx="533263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sociated herbivores and quantification of the different damage types observed  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hree experimental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415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8</TotalTime>
  <Words>113</Words>
  <Application>Microsoft Office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ahoma</vt:lpstr>
      <vt:lpstr>Times New Roman</vt:lpstr>
      <vt:lpstr>Office Theme</vt:lpstr>
      <vt:lpstr>PowerPoint Presentation</vt:lpstr>
    </vt:vector>
  </TitlesOfParts>
  <Company>MPI for chemical ecolog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b</dc:creator>
  <cp:lastModifiedBy>Ricardo Machado</cp:lastModifiedBy>
  <cp:revision>157</cp:revision>
  <cp:lastPrinted>2012-12-20T15:42:23Z</cp:lastPrinted>
  <dcterms:created xsi:type="dcterms:W3CDTF">2012-11-03T11:02:56Z</dcterms:created>
  <dcterms:modified xsi:type="dcterms:W3CDTF">2016-05-02T13:44:45Z</dcterms:modified>
</cp:coreProperties>
</file>